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7E05F-6D13-4F38-9F87-9FF2226814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1043F-C497-473F-80E4-20B3EA59E7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FA5C5-5806-40F2-BF71-DDE889E03B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EEF63-4DE1-44B0-A055-AA073F7E1C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1658E3-FA0A-44BD-9F6E-1B852FB46B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2FFB4-5119-41B0-8C53-DCFAF20461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7FD72-7023-4D0A-9CA9-2982DC0FC7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D3A48-AF5B-4BC6-ABF4-9C4E4975C6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8CC65-F02C-482F-A3ED-CD0FF87AD0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6B10B-CBD3-4548-89AC-A514888915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682F8-55A9-472B-9A90-A5EE43C3DD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31F8A-051E-4680-8A8C-70517AC99C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C65957-43F7-4821-A983-37E663B1D34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"/>
          <p:cNvSpPr/>
          <p:nvPr/>
        </p:nvSpPr>
        <p:spPr>
          <a:xfrm>
            <a:off x="555480" y="709560"/>
            <a:ext cx="2882880" cy="82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upplementary Tabl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The Sequences of Quantitative PCR prime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6"/>
          <p:cNvSpPr/>
          <p:nvPr/>
        </p:nvSpPr>
        <p:spPr>
          <a:xfrm>
            <a:off x="978480" y="1684440"/>
            <a:ext cx="320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Ge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7"/>
          <p:cNvSpPr/>
          <p:nvPr/>
        </p:nvSpPr>
        <p:spPr>
          <a:xfrm>
            <a:off x="2611800" y="1684440"/>
            <a:ext cx="1069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rimer sequenc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8"/>
          <p:cNvSpPr/>
          <p:nvPr/>
        </p:nvSpPr>
        <p:spPr>
          <a:xfrm>
            <a:off x="991440" y="1973160"/>
            <a:ext cx="43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xcl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9"/>
          <p:cNvSpPr/>
          <p:nvPr/>
        </p:nvSpPr>
        <p:spPr>
          <a:xfrm>
            <a:off x="1854720" y="1960560"/>
            <a:ext cx="2251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CAA CCC AAG TGC TGC C- 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10"/>
          <p:cNvSpPr/>
          <p:nvPr/>
        </p:nvSpPr>
        <p:spPr>
          <a:xfrm>
            <a:off x="1855440" y="2160720"/>
            <a:ext cx="3015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GGG AAT TCA CCA TGG CTT GAC CA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ctangle 11"/>
          <p:cNvSpPr/>
          <p:nvPr/>
        </p:nvSpPr>
        <p:spPr>
          <a:xfrm>
            <a:off x="990720" y="2373480"/>
            <a:ext cx="288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cl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 12"/>
          <p:cNvSpPr/>
          <p:nvPr/>
        </p:nvSpPr>
        <p:spPr>
          <a:xfrm>
            <a:off x="1855800" y="2360520"/>
            <a:ext cx="2562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CCC TTC GGG TGC TGA AAA G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13"/>
          <p:cNvSpPr/>
          <p:nvPr/>
        </p:nvSpPr>
        <p:spPr>
          <a:xfrm>
            <a:off x="1857960" y="2573280"/>
            <a:ext cx="3219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AGG TCT TTT GCG GGA TTT GTA GTG G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4"/>
          <p:cNvSpPr/>
          <p:nvPr/>
        </p:nvSpPr>
        <p:spPr>
          <a:xfrm>
            <a:off x="991440" y="2771640"/>
            <a:ext cx="35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xcl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15"/>
          <p:cNvSpPr/>
          <p:nvPr/>
        </p:nvSpPr>
        <p:spPr>
          <a:xfrm>
            <a:off x="1855440" y="2771640"/>
            <a:ext cx="2554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AAT GCA CGA TGC TCC TGC A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6"/>
          <p:cNvSpPr/>
          <p:nvPr/>
        </p:nvSpPr>
        <p:spPr>
          <a:xfrm>
            <a:off x="1857600" y="2971800"/>
            <a:ext cx="3088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AGG TCT TTG CGG GAT TTG TAG TGG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7"/>
          <p:cNvSpPr/>
          <p:nvPr/>
        </p:nvSpPr>
        <p:spPr>
          <a:xfrm>
            <a:off x="991440" y="3171960"/>
            <a:ext cx="35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xcl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18"/>
          <p:cNvSpPr/>
          <p:nvPr/>
        </p:nvSpPr>
        <p:spPr>
          <a:xfrm>
            <a:off x="1855800" y="3171960"/>
            <a:ext cx="2390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TGG GCT GCT GTC CCT CAA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19"/>
          <p:cNvSpPr/>
          <p:nvPr/>
        </p:nvSpPr>
        <p:spPr>
          <a:xfrm>
            <a:off x="1857960" y="3371760"/>
            <a:ext cx="2486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CCC GGG TGC TGT TTG TTT T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20"/>
          <p:cNvSpPr/>
          <p:nvPr/>
        </p:nvSpPr>
        <p:spPr>
          <a:xfrm>
            <a:off x="990720" y="3571920"/>
            <a:ext cx="365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cl2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tangle 21"/>
          <p:cNvSpPr/>
          <p:nvPr/>
        </p:nvSpPr>
        <p:spPr>
          <a:xfrm>
            <a:off x="1854720" y="3571920"/>
            <a:ext cx="2939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ATA GGC AAT ACA CGC TAC AAG C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22"/>
          <p:cNvSpPr/>
          <p:nvPr/>
        </p:nvSpPr>
        <p:spPr>
          <a:xfrm>
            <a:off x="1855800" y="3772080"/>
            <a:ext cx="4161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GCG GAA TTC GTC TTC AAA GGC ACC TTG GGG CAT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23"/>
          <p:cNvSpPr/>
          <p:nvPr/>
        </p:nvSpPr>
        <p:spPr>
          <a:xfrm>
            <a:off x="996120" y="3971880"/>
            <a:ext cx="291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IL1α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24"/>
          <p:cNvSpPr/>
          <p:nvPr/>
        </p:nvSpPr>
        <p:spPr>
          <a:xfrm>
            <a:off x="1855440" y="3971880"/>
            <a:ext cx="2594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TTC AAG GAG AGC CGG GTG A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25"/>
          <p:cNvSpPr/>
          <p:nvPr/>
        </p:nvSpPr>
        <p:spPr>
          <a:xfrm>
            <a:off x="1857240" y="4184640"/>
            <a:ext cx="2644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TGC TGA TCT GGG TTG GAT GG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26"/>
          <p:cNvSpPr/>
          <p:nvPr/>
        </p:nvSpPr>
        <p:spPr>
          <a:xfrm>
            <a:off x="994680" y="4387680"/>
            <a:ext cx="67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Defensin-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α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27"/>
          <p:cNvSpPr/>
          <p:nvPr/>
        </p:nvSpPr>
        <p:spPr>
          <a:xfrm>
            <a:off x="1855080" y="4387680"/>
            <a:ext cx="3399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GCA TTT GAG GAA AGG AAC TCC ACA AC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28"/>
          <p:cNvSpPr/>
          <p:nvPr/>
        </p:nvSpPr>
        <p:spPr>
          <a:xfrm>
            <a:off x="1855800" y="4587840"/>
            <a:ext cx="3076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GTC TCC ACC TGC AGC TTT TAG CAA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29"/>
          <p:cNvSpPr/>
          <p:nvPr/>
        </p:nvSpPr>
        <p:spPr>
          <a:xfrm>
            <a:off x="998640" y="4788000"/>
            <a:ext cx="52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LM-β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30"/>
          <p:cNvSpPr/>
          <p:nvPr/>
        </p:nvSpPr>
        <p:spPr>
          <a:xfrm>
            <a:off x="1857960" y="4788000"/>
            <a:ext cx="2595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TGG CTT TGC CTG TGG ATC TT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31"/>
          <p:cNvSpPr/>
          <p:nvPr/>
        </p:nvSpPr>
        <p:spPr>
          <a:xfrm>
            <a:off x="1855440" y="4987800"/>
            <a:ext cx="2929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GCA GTG GTC CAG TCA ACG AGT A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32"/>
          <p:cNvSpPr/>
          <p:nvPr/>
        </p:nvSpPr>
        <p:spPr>
          <a:xfrm>
            <a:off x="987480" y="5194440"/>
            <a:ext cx="474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100A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ectangle 33"/>
          <p:cNvSpPr/>
          <p:nvPr/>
        </p:nvSpPr>
        <p:spPr>
          <a:xfrm>
            <a:off x="1854000" y="5194440"/>
            <a:ext cx="3330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TGT CCT CAG TTT GTG CAG AAT ATA AA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34"/>
          <p:cNvSpPr/>
          <p:nvPr/>
        </p:nvSpPr>
        <p:spPr>
          <a:xfrm>
            <a:off x="1851480" y="5394240"/>
            <a:ext cx="2666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TCA CCA TCG CAA GGA ACT CC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35"/>
          <p:cNvSpPr/>
          <p:nvPr/>
        </p:nvSpPr>
        <p:spPr>
          <a:xfrm>
            <a:off x="991080" y="5594400"/>
            <a:ext cx="464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gIII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β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36"/>
          <p:cNvSpPr/>
          <p:nvPr/>
        </p:nvSpPr>
        <p:spPr>
          <a:xfrm>
            <a:off x="1852560" y="5594400"/>
            <a:ext cx="2623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ATG GCT CCT ACT GCT ATG CC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37"/>
          <p:cNvSpPr/>
          <p:nvPr/>
        </p:nvSpPr>
        <p:spPr>
          <a:xfrm>
            <a:off x="1853280" y="5794200"/>
            <a:ext cx="2496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GTG TCC TCC AGG CCT CTT T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38"/>
          <p:cNvSpPr/>
          <p:nvPr/>
        </p:nvSpPr>
        <p:spPr>
          <a:xfrm>
            <a:off x="654120" y="1935000"/>
            <a:ext cx="5229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Line 39"/>
          <p:cNvSpPr/>
          <p:nvPr/>
        </p:nvSpPr>
        <p:spPr>
          <a:xfrm>
            <a:off x="660240" y="6948360"/>
            <a:ext cx="5229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32"/>
          <p:cNvSpPr/>
          <p:nvPr/>
        </p:nvSpPr>
        <p:spPr>
          <a:xfrm>
            <a:off x="987480" y="6060960"/>
            <a:ext cx="61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laudin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33"/>
          <p:cNvSpPr/>
          <p:nvPr/>
        </p:nvSpPr>
        <p:spPr>
          <a:xfrm>
            <a:off x="1850400" y="6060960"/>
            <a:ext cx="2455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ACCGCCTACCCGGACCAG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34"/>
          <p:cNvSpPr/>
          <p:nvPr/>
        </p:nvSpPr>
        <p:spPr>
          <a:xfrm>
            <a:off x="1851120" y="6261120"/>
            <a:ext cx="2454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CGCACCTGAGCTCCCGAA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Rectangle 32"/>
          <p:cNvSpPr/>
          <p:nvPr/>
        </p:nvSpPr>
        <p:spPr>
          <a:xfrm>
            <a:off x="987480" y="6516720"/>
            <a:ext cx="61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laudin-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Rectangle 33"/>
          <p:cNvSpPr/>
          <p:nvPr/>
        </p:nvSpPr>
        <p:spPr>
          <a:xfrm>
            <a:off x="1852560" y="6516720"/>
            <a:ext cx="2317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GCTGTTAGGCACATCCA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34"/>
          <p:cNvSpPr/>
          <p:nvPr/>
        </p:nvSpPr>
        <p:spPr>
          <a:xfrm>
            <a:off x="1851840" y="6716880"/>
            <a:ext cx="2452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’-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GGCACCAACATAGGAAC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-3’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6T06:46:13Z</dcterms:created>
  <dc:creator>HanLab</dc:creator>
  <dc:description/>
  <dc:language>en-US</dc:language>
  <cp:lastModifiedBy>HanLab</cp:lastModifiedBy>
  <dcterms:modified xsi:type="dcterms:W3CDTF">2010-04-26T07:15:42Z</dcterms:modified>
  <cp:revision>1</cp:revision>
  <dc:subject/>
  <dc:title>幻灯片 1</dc:title>
</cp:coreProperties>
</file>